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78" r:id="rId3"/>
    <p:sldId id="257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82"/>
  </p:normalViewPr>
  <p:slideViewPr>
    <p:cSldViewPr snapToGrid="0" snapToObjects="1">
      <p:cViewPr varScale="1">
        <p:scale>
          <a:sx n="93" d="100"/>
          <a:sy n="93" d="100"/>
        </p:scale>
        <p:origin x="222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554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460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532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572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015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578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542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493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815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109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849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DBBD8C-B2CD-9C4D-92BB-382D4971C649}" type="datetimeFigureOut">
              <a:rPr lang="en-US" smtClean="0"/>
              <a:t>3/2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11CF1-919E-7940-8029-702CEDD4A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098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>
            <a:extLst>
              <a:ext uri="{FF2B5EF4-FFF2-40B4-BE49-F238E27FC236}">
                <a16:creationId xmlns:a16="http://schemas.microsoft.com/office/drawing/2014/main" id="{20749FE0-B569-6543-B7AE-48C50008ADA2}"/>
              </a:ext>
            </a:extLst>
          </p:cNvPr>
          <p:cNvGrpSpPr/>
          <p:nvPr/>
        </p:nvGrpSpPr>
        <p:grpSpPr>
          <a:xfrm>
            <a:off x="1437508" y="620734"/>
            <a:ext cx="2514600" cy="379213"/>
            <a:chOff x="1858453" y="181094"/>
            <a:chExt cx="2514600" cy="379213"/>
          </a:xfrm>
        </p:grpSpPr>
        <p:sp>
          <p:nvSpPr>
            <p:cNvPr id="4" name="Rounded Rectangle 3">
              <a:extLst>
                <a:ext uri="{FF2B5EF4-FFF2-40B4-BE49-F238E27FC236}">
                  <a16:creationId xmlns:a16="http://schemas.microsoft.com/office/drawing/2014/main" id="{7E879828-D37D-5440-8EAB-E12A41A15B52}"/>
                </a:ext>
              </a:extLst>
            </p:cNvPr>
            <p:cNvSpPr/>
            <p:nvPr/>
          </p:nvSpPr>
          <p:spPr>
            <a:xfrm>
              <a:off x="1858453" y="182881"/>
              <a:ext cx="2514600" cy="377426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244A95A-DD0A-5848-8950-A25486E4D065}"/>
                </a:ext>
              </a:extLst>
            </p:cNvPr>
            <p:cNvSpPr txBox="1"/>
            <p:nvPr/>
          </p:nvSpPr>
          <p:spPr>
            <a:xfrm>
              <a:off x="2080855" y="181094"/>
              <a:ext cx="2069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arvest Plant Tissue</a:t>
              </a:r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A6C5D9A5-E0C2-814B-9EBE-45EA5F6F49E4}"/>
              </a:ext>
            </a:extLst>
          </p:cNvPr>
          <p:cNvGrpSpPr/>
          <p:nvPr/>
        </p:nvGrpSpPr>
        <p:grpSpPr>
          <a:xfrm>
            <a:off x="1437508" y="1125441"/>
            <a:ext cx="2561889" cy="396238"/>
            <a:chOff x="1858453" y="685801"/>
            <a:chExt cx="2561889" cy="396238"/>
          </a:xfrm>
        </p:grpSpPr>
        <p:sp>
          <p:nvSpPr>
            <p:cNvPr id="6" name="Rounded Rectangle 5">
              <a:extLst>
                <a:ext uri="{FF2B5EF4-FFF2-40B4-BE49-F238E27FC236}">
                  <a16:creationId xmlns:a16="http://schemas.microsoft.com/office/drawing/2014/main" id="{8F147FBE-8EC9-714A-9962-E2261805DDD3}"/>
                </a:ext>
              </a:extLst>
            </p:cNvPr>
            <p:cNvSpPr/>
            <p:nvPr/>
          </p:nvSpPr>
          <p:spPr>
            <a:xfrm>
              <a:off x="1858453" y="685801"/>
              <a:ext cx="2514600" cy="396238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D227BE0-FEEA-9E47-A3CB-7C0CC16D106B}"/>
                </a:ext>
              </a:extLst>
            </p:cNvPr>
            <p:cNvSpPr txBox="1"/>
            <p:nvPr/>
          </p:nvSpPr>
          <p:spPr>
            <a:xfrm>
              <a:off x="1932994" y="697469"/>
              <a:ext cx="24873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iquid Nitrogen Grinding</a:t>
              </a:r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08F4B6E4-9D92-E149-B876-8B57205C58AF}"/>
              </a:ext>
            </a:extLst>
          </p:cNvPr>
          <p:cNvGrpSpPr/>
          <p:nvPr/>
        </p:nvGrpSpPr>
        <p:grpSpPr>
          <a:xfrm>
            <a:off x="1437092" y="3240231"/>
            <a:ext cx="2515432" cy="396238"/>
            <a:chOff x="1858037" y="3425431"/>
            <a:chExt cx="2515432" cy="396238"/>
          </a:xfrm>
        </p:grpSpPr>
        <p:sp>
          <p:nvSpPr>
            <p:cNvPr id="8" name="Rounded Rectangle 7">
              <a:extLst>
                <a:ext uri="{FF2B5EF4-FFF2-40B4-BE49-F238E27FC236}">
                  <a16:creationId xmlns:a16="http://schemas.microsoft.com/office/drawing/2014/main" id="{EBCC4A16-FEC6-2D45-BEC6-4DAF30342B95}"/>
                </a:ext>
              </a:extLst>
            </p:cNvPr>
            <p:cNvSpPr/>
            <p:nvPr/>
          </p:nvSpPr>
          <p:spPr>
            <a:xfrm>
              <a:off x="1858453" y="3425431"/>
              <a:ext cx="2514600" cy="396238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918E503-96BF-D846-8816-E796895610DD}"/>
                </a:ext>
              </a:extLst>
            </p:cNvPr>
            <p:cNvSpPr txBox="1"/>
            <p:nvPr/>
          </p:nvSpPr>
          <p:spPr>
            <a:xfrm>
              <a:off x="1858037" y="3440671"/>
              <a:ext cx="25154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mbed Nuclei in Agarose</a:t>
              </a:r>
            </a:p>
          </p:txBody>
        </p: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8AA054D4-5EF2-3E44-94EF-10C2CD105900}"/>
              </a:ext>
            </a:extLst>
          </p:cNvPr>
          <p:cNvGrpSpPr/>
          <p:nvPr/>
        </p:nvGrpSpPr>
        <p:grpSpPr>
          <a:xfrm>
            <a:off x="1356686" y="3761958"/>
            <a:ext cx="2676245" cy="380998"/>
            <a:chOff x="1792871" y="3947158"/>
            <a:chExt cx="2676245" cy="380998"/>
          </a:xfrm>
        </p:grpSpPr>
        <p:sp>
          <p:nvSpPr>
            <p:cNvPr id="10" name="Rounded Rectangle 9">
              <a:extLst>
                <a:ext uri="{FF2B5EF4-FFF2-40B4-BE49-F238E27FC236}">
                  <a16:creationId xmlns:a16="http://schemas.microsoft.com/office/drawing/2014/main" id="{29F5DB01-632E-134E-A693-838BBA7C418B}"/>
                </a:ext>
              </a:extLst>
            </p:cNvPr>
            <p:cNvSpPr/>
            <p:nvPr/>
          </p:nvSpPr>
          <p:spPr>
            <a:xfrm>
              <a:off x="1858453" y="3958824"/>
              <a:ext cx="2514600" cy="36933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2BB8A49-4A31-6940-96E2-CED12B7BAB58}"/>
                </a:ext>
              </a:extLst>
            </p:cNvPr>
            <p:cNvSpPr txBox="1"/>
            <p:nvPr/>
          </p:nvSpPr>
          <p:spPr>
            <a:xfrm>
              <a:off x="1792871" y="3947158"/>
              <a:ext cx="26762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roteinase K digestion (2x)</a:t>
              </a:r>
            </a:p>
          </p:txBody>
        </p: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33BA1D26-04F2-604A-927C-32D4EAA35DBF}"/>
              </a:ext>
            </a:extLst>
          </p:cNvPr>
          <p:cNvGrpSpPr/>
          <p:nvPr/>
        </p:nvGrpSpPr>
        <p:grpSpPr>
          <a:xfrm>
            <a:off x="1437508" y="4264879"/>
            <a:ext cx="2514600" cy="369332"/>
            <a:chOff x="1858038" y="4450079"/>
            <a:chExt cx="2514600" cy="369332"/>
          </a:xfrm>
        </p:grpSpPr>
        <p:sp>
          <p:nvSpPr>
            <p:cNvPr id="12" name="Rounded Rectangle 11">
              <a:extLst>
                <a:ext uri="{FF2B5EF4-FFF2-40B4-BE49-F238E27FC236}">
                  <a16:creationId xmlns:a16="http://schemas.microsoft.com/office/drawing/2014/main" id="{870B885D-22E8-A14F-B6C5-90B5EDD3D360}"/>
                </a:ext>
              </a:extLst>
            </p:cNvPr>
            <p:cNvSpPr/>
            <p:nvPr/>
          </p:nvSpPr>
          <p:spPr>
            <a:xfrm>
              <a:off x="1858038" y="4458180"/>
              <a:ext cx="2514600" cy="340634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EDD0A9C-8413-5C41-9182-343D8A26FAA3}"/>
                </a:ext>
              </a:extLst>
            </p:cNvPr>
            <p:cNvSpPr txBox="1"/>
            <p:nvPr/>
          </p:nvSpPr>
          <p:spPr>
            <a:xfrm>
              <a:off x="2132954" y="4450079"/>
              <a:ext cx="19647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RNase A treatment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76800CA6-ED48-C14F-9C13-AC8B21DAC52D}"/>
              </a:ext>
            </a:extLst>
          </p:cNvPr>
          <p:cNvGrpSpPr/>
          <p:nvPr/>
        </p:nvGrpSpPr>
        <p:grpSpPr>
          <a:xfrm>
            <a:off x="1437508" y="4747199"/>
            <a:ext cx="2514600" cy="369332"/>
            <a:chOff x="1856148" y="4932399"/>
            <a:chExt cx="2514600" cy="369332"/>
          </a:xfrm>
        </p:grpSpPr>
        <p:sp>
          <p:nvSpPr>
            <p:cNvPr id="14" name="Rounded Rectangle 13">
              <a:extLst>
                <a:ext uri="{FF2B5EF4-FFF2-40B4-BE49-F238E27FC236}">
                  <a16:creationId xmlns:a16="http://schemas.microsoft.com/office/drawing/2014/main" id="{BF5D716D-B811-444A-9E04-96BF93F8DC9E}"/>
                </a:ext>
              </a:extLst>
            </p:cNvPr>
            <p:cNvSpPr/>
            <p:nvPr/>
          </p:nvSpPr>
          <p:spPr>
            <a:xfrm>
              <a:off x="1856148" y="4932399"/>
              <a:ext cx="2514600" cy="36933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6BE9E64-A064-AA42-994E-EB9C62CD3AC3}"/>
                </a:ext>
              </a:extLst>
            </p:cNvPr>
            <p:cNvSpPr txBox="1"/>
            <p:nvPr/>
          </p:nvSpPr>
          <p:spPr>
            <a:xfrm>
              <a:off x="2488918" y="4932399"/>
              <a:ext cx="12490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ash Plugs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5419D7F9-EDE5-D24A-B48B-2ED0F0E8ACC8}"/>
              </a:ext>
            </a:extLst>
          </p:cNvPr>
          <p:cNvGrpSpPr/>
          <p:nvPr/>
        </p:nvGrpSpPr>
        <p:grpSpPr>
          <a:xfrm>
            <a:off x="2531594" y="5817297"/>
            <a:ext cx="3911323" cy="506650"/>
            <a:chOff x="1903858" y="4334468"/>
            <a:chExt cx="2999549" cy="369332"/>
          </a:xfrm>
        </p:grpSpPr>
        <p:sp>
          <p:nvSpPr>
            <p:cNvPr id="22" name="Rounded Rectangle 21">
              <a:extLst>
                <a:ext uri="{FF2B5EF4-FFF2-40B4-BE49-F238E27FC236}">
                  <a16:creationId xmlns:a16="http://schemas.microsoft.com/office/drawing/2014/main" id="{ED3FD0BB-AA49-1E47-85D2-FBBFB62E649C}"/>
                </a:ext>
              </a:extLst>
            </p:cNvPr>
            <p:cNvSpPr/>
            <p:nvPr/>
          </p:nvSpPr>
          <p:spPr>
            <a:xfrm>
              <a:off x="1903858" y="4334468"/>
              <a:ext cx="2953574" cy="36933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5AABA51-1322-6348-8EF2-4ADF1A4E9568}"/>
                </a:ext>
              </a:extLst>
            </p:cNvPr>
            <p:cNvSpPr txBox="1"/>
            <p:nvPr/>
          </p:nvSpPr>
          <p:spPr>
            <a:xfrm>
              <a:off x="2013330" y="4384749"/>
              <a:ext cx="2890077" cy="269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Restriction Endonuclease Digestion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6CF2BDEF-EDFE-7241-9C3F-4EBB78538427}"/>
              </a:ext>
            </a:extLst>
          </p:cNvPr>
          <p:cNvGrpSpPr/>
          <p:nvPr/>
        </p:nvGrpSpPr>
        <p:grpSpPr>
          <a:xfrm>
            <a:off x="1437508" y="6384192"/>
            <a:ext cx="2514600" cy="380998"/>
            <a:chOff x="1863762" y="6767512"/>
            <a:chExt cx="2514600" cy="380998"/>
          </a:xfrm>
        </p:grpSpPr>
        <p:sp>
          <p:nvSpPr>
            <p:cNvPr id="34" name="Rounded Rectangle 33">
              <a:extLst>
                <a:ext uri="{FF2B5EF4-FFF2-40B4-BE49-F238E27FC236}">
                  <a16:creationId xmlns:a16="http://schemas.microsoft.com/office/drawing/2014/main" id="{FE38F471-C7D8-7C44-B522-796B84AF5E3E}"/>
                </a:ext>
              </a:extLst>
            </p:cNvPr>
            <p:cNvSpPr/>
            <p:nvPr/>
          </p:nvSpPr>
          <p:spPr>
            <a:xfrm>
              <a:off x="1863762" y="6779178"/>
              <a:ext cx="2514600" cy="36933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D09B90E-6C2B-B74A-B9E8-544B4562400F}"/>
                </a:ext>
              </a:extLst>
            </p:cNvPr>
            <p:cNvSpPr txBox="1"/>
            <p:nvPr/>
          </p:nvSpPr>
          <p:spPr>
            <a:xfrm>
              <a:off x="2177535" y="6767512"/>
              <a:ext cx="18870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elt Agarose Plug</a:t>
              </a: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35F593EF-7239-6D49-89A9-710C7D3797BB}"/>
              </a:ext>
            </a:extLst>
          </p:cNvPr>
          <p:cNvGrpSpPr/>
          <p:nvPr/>
        </p:nvGrpSpPr>
        <p:grpSpPr>
          <a:xfrm>
            <a:off x="1437508" y="6856633"/>
            <a:ext cx="2514600" cy="379215"/>
            <a:chOff x="1858038" y="7239953"/>
            <a:chExt cx="2514600" cy="379215"/>
          </a:xfrm>
        </p:grpSpPr>
        <p:sp>
          <p:nvSpPr>
            <p:cNvPr id="36" name="Rounded Rectangle 35">
              <a:extLst>
                <a:ext uri="{FF2B5EF4-FFF2-40B4-BE49-F238E27FC236}">
                  <a16:creationId xmlns:a16="http://schemas.microsoft.com/office/drawing/2014/main" id="{791C3115-01E7-434A-BFC4-E4846BA1A2A3}"/>
                </a:ext>
              </a:extLst>
            </p:cNvPr>
            <p:cNvSpPr/>
            <p:nvPr/>
          </p:nvSpPr>
          <p:spPr>
            <a:xfrm>
              <a:off x="1858038" y="7278534"/>
              <a:ext cx="2514600" cy="340634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5FA33AC-48B0-0C45-B6EA-90F4DA68AA70}"/>
                </a:ext>
              </a:extLst>
            </p:cNvPr>
            <p:cNvSpPr txBox="1"/>
            <p:nvPr/>
          </p:nvSpPr>
          <p:spPr>
            <a:xfrm>
              <a:off x="2163286" y="7239953"/>
              <a:ext cx="20290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igest with </a:t>
              </a:r>
              <a:r>
                <a:rPr lang="en-US" dirty="0" err="1"/>
                <a:t>Agarase</a:t>
              </a:r>
              <a:endParaRPr lang="en-US" dirty="0"/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DA51E645-6B73-6742-8AD5-320C58CC8033}"/>
              </a:ext>
            </a:extLst>
          </p:cNvPr>
          <p:cNvGrpSpPr/>
          <p:nvPr/>
        </p:nvGrpSpPr>
        <p:grpSpPr>
          <a:xfrm>
            <a:off x="1437508" y="7369433"/>
            <a:ext cx="2514600" cy="369332"/>
            <a:chOff x="1875766" y="7752753"/>
            <a:chExt cx="2514600" cy="369332"/>
          </a:xfrm>
        </p:grpSpPr>
        <p:sp>
          <p:nvSpPr>
            <p:cNvPr id="38" name="Rounded Rectangle 37">
              <a:extLst>
                <a:ext uri="{FF2B5EF4-FFF2-40B4-BE49-F238E27FC236}">
                  <a16:creationId xmlns:a16="http://schemas.microsoft.com/office/drawing/2014/main" id="{9203941E-2637-8243-A27D-97055DEA9825}"/>
                </a:ext>
              </a:extLst>
            </p:cNvPr>
            <p:cNvSpPr/>
            <p:nvPr/>
          </p:nvSpPr>
          <p:spPr>
            <a:xfrm>
              <a:off x="1875766" y="7752753"/>
              <a:ext cx="2514600" cy="36933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98F8FE7-4658-5141-9DA4-D80708CC910C}"/>
                </a:ext>
              </a:extLst>
            </p:cNvPr>
            <p:cNvSpPr txBox="1"/>
            <p:nvPr/>
          </p:nvSpPr>
          <p:spPr>
            <a:xfrm>
              <a:off x="2020133" y="7752753"/>
              <a:ext cx="21168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rop Dialysis of DNA</a:t>
              </a:r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4EA54FA8-361C-B84C-8883-EF5379AC9358}"/>
              </a:ext>
            </a:extLst>
          </p:cNvPr>
          <p:cNvGrpSpPr/>
          <p:nvPr/>
        </p:nvGrpSpPr>
        <p:grpSpPr>
          <a:xfrm>
            <a:off x="1437508" y="7873305"/>
            <a:ext cx="2514600" cy="369332"/>
            <a:chOff x="1875766" y="8256625"/>
            <a:chExt cx="2514600" cy="369332"/>
          </a:xfrm>
        </p:grpSpPr>
        <p:sp>
          <p:nvSpPr>
            <p:cNvPr id="40" name="Rounded Rectangle 39">
              <a:extLst>
                <a:ext uri="{FF2B5EF4-FFF2-40B4-BE49-F238E27FC236}">
                  <a16:creationId xmlns:a16="http://schemas.microsoft.com/office/drawing/2014/main" id="{5B926CBE-5AA0-4C46-A1FE-E79890A50F0E}"/>
                </a:ext>
              </a:extLst>
            </p:cNvPr>
            <p:cNvSpPr/>
            <p:nvPr/>
          </p:nvSpPr>
          <p:spPr>
            <a:xfrm>
              <a:off x="1875766" y="8256625"/>
              <a:ext cx="2514600" cy="36933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F7738EE-773E-A04C-BB3D-35AE9AC38D92}"/>
                </a:ext>
              </a:extLst>
            </p:cNvPr>
            <p:cNvSpPr txBox="1"/>
            <p:nvPr/>
          </p:nvSpPr>
          <p:spPr>
            <a:xfrm>
              <a:off x="2242406" y="8256625"/>
              <a:ext cx="14757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Quantify DNA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8D522726-C290-CC43-8DF2-E02B77449214}"/>
              </a:ext>
            </a:extLst>
          </p:cNvPr>
          <p:cNvGrpSpPr/>
          <p:nvPr/>
        </p:nvGrpSpPr>
        <p:grpSpPr>
          <a:xfrm>
            <a:off x="1437508" y="1655264"/>
            <a:ext cx="2514600" cy="396238"/>
            <a:chOff x="1846776" y="1215624"/>
            <a:chExt cx="2514600" cy="396238"/>
          </a:xfrm>
        </p:grpSpPr>
        <p:sp>
          <p:nvSpPr>
            <p:cNvPr id="42" name="Rounded Rectangle 41">
              <a:extLst>
                <a:ext uri="{FF2B5EF4-FFF2-40B4-BE49-F238E27FC236}">
                  <a16:creationId xmlns:a16="http://schemas.microsoft.com/office/drawing/2014/main" id="{AE81A306-F9BB-DB41-B782-9C836E30F217}"/>
                </a:ext>
              </a:extLst>
            </p:cNvPr>
            <p:cNvSpPr/>
            <p:nvPr/>
          </p:nvSpPr>
          <p:spPr>
            <a:xfrm>
              <a:off x="1846776" y="1215624"/>
              <a:ext cx="2514600" cy="396238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1FF2175-F572-A640-AE98-D5306F11DE12}"/>
                </a:ext>
              </a:extLst>
            </p:cNvPr>
            <p:cNvSpPr txBox="1"/>
            <p:nvPr/>
          </p:nvSpPr>
          <p:spPr>
            <a:xfrm>
              <a:off x="2335436" y="1231062"/>
              <a:ext cx="15372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lant Cell Lysis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1E1F224E-3E8B-1148-9C8F-42682A72493A}"/>
              </a:ext>
            </a:extLst>
          </p:cNvPr>
          <p:cNvGrpSpPr/>
          <p:nvPr/>
        </p:nvGrpSpPr>
        <p:grpSpPr>
          <a:xfrm>
            <a:off x="934679" y="2179999"/>
            <a:ext cx="3520259" cy="377990"/>
            <a:chOff x="1308754" y="1740359"/>
            <a:chExt cx="3520259" cy="377990"/>
          </a:xfrm>
        </p:grpSpPr>
        <p:sp>
          <p:nvSpPr>
            <p:cNvPr id="44" name="Rounded Rectangle 43">
              <a:extLst>
                <a:ext uri="{FF2B5EF4-FFF2-40B4-BE49-F238E27FC236}">
                  <a16:creationId xmlns:a16="http://schemas.microsoft.com/office/drawing/2014/main" id="{16533915-A890-6A4F-8126-32EDE42BD130}"/>
                </a:ext>
              </a:extLst>
            </p:cNvPr>
            <p:cNvSpPr/>
            <p:nvPr/>
          </p:nvSpPr>
          <p:spPr>
            <a:xfrm>
              <a:off x="1308755" y="1749017"/>
              <a:ext cx="3520258" cy="36933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720D374-F25F-7549-B9E5-B9ADF3420B32}"/>
                </a:ext>
              </a:extLst>
            </p:cNvPr>
            <p:cNvSpPr txBox="1"/>
            <p:nvPr/>
          </p:nvSpPr>
          <p:spPr>
            <a:xfrm>
              <a:off x="1308754" y="1740359"/>
              <a:ext cx="35202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ellet, Wash, and Resuspend Nuclei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63DB29B3-A349-AC49-8A25-8EC4E5FE4D9B}"/>
              </a:ext>
            </a:extLst>
          </p:cNvPr>
          <p:cNvGrpSpPr/>
          <p:nvPr/>
        </p:nvGrpSpPr>
        <p:grpSpPr>
          <a:xfrm>
            <a:off x="1177381" y="2691574"/>
            <a:ext cx="3034854" cy="396238"/>
            <a:chOff x="1569720" y="2251934"/>
            <a:chExt cx="3034854" cy="396238"/>
          </a:xfrm>
        </p:grpSpPr>
        <p:sp>
          <p:nvSpPr>
            <p:cNvPr id="47" name="Rounded Rectangle 46">
              <a:extLst>
                <a:ext uri="{FF2B5EF4-FFF2-40B4-BE49-F238E27FC236}">
                  <a16:creationId xmlns:a16="http://schemas.microsoft.com/office/drawing/2014/main" id="{D62DE44B-295E-184C-9ED1-9BF212B1548B}"/>
                </a:ext>
              </a:extLst>
            </p:cNvPr>
            <p:cNvSpPr/>
            <p:nvPr/>
          </p:nvSpPr>
          <p:spPr>
            <a:xfrm>
              <a:off x="1569720" y="2251934"/>
              <a:ext cx="3034854" cy="396238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C8433C8-E526-A444-AC99-7FEEE48623A5}"/>
                </a:ext>
              </a:extLst>
            </p:cNvPr>
            <p:cNvSpPr txBox="1"/>
            <p:nvPr/>
          </p:nvSpPr>
          <p:spPr>
            <a:xfrm>
              <a:off x="1569720" y="2267174"/>
              <a:ext cx="30348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adient Purification of Nuclei</a:t>
              </a:r>
            </a:p>
          </p:txBody>
        </p:sp>
      </p:grpSp>
      <p:sp>
        <p:nvSpPr>
          <p:cNvPr id="63" name="Down Arrow 62">
            <a:extLst>
              <a:ext uri="{FF2B5EF4-FFF2-40B4-BE49-F238E27FC236}">
                <a16:creationId xmlns:a16="http://schemas.microsoft.com/office/drawing/2014/main" id="{0D26EDA1-1A05-404B-877E-E8A5E9667256}"/>
              </a:ext>
            </a:extLst>
          </p:cNvPr>
          <p:cNvSpPr/>
          <p:nvPr/>
        </p:nvSpPr>
        <p:spPr>
          <a:xfrm>
            <a:off x="2198712" y="5391540"/>
            <a:ext cx="106680" cy="80635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3896E437-E4E6-4F40-8A27-B05F0CE9BB6F}"/>
              </a:ext>
            </a:extLst>
          </p:cNvPr>
          <p:cNvGrpSpPr/>
          <p:nvPr/>
        </p:nvGrpSpPr>
        <p:grpSpPr>
          <a:xfrm>
            <a:off x="2369147" y="5231840"/>
            <a:ext cx="4599687" cy="442534"/>
            <a:chOff x="3464874" y="4838601"/>
            <a:chExt cx="4599687" cy="442534"/>
          </a:xfrm>
        </p:grpSpPr>
        <p:sp>
          <p:nvSpPr>
            <p:cNvPr id="30" name="Rounded Rectangle 29">
              <a:extLst>
                <a:ext uri="{FF2B5EF4-FFF2-40B4-BE49-F238E27FC236}">
                  <a16:creationId xmlns:a16="http://schemas.microsoft.com/office/drawing/2014/main" id="{8F37D3BA-3318-A948-AF09-102E4B343CDD}"/>
                </a:ext>
              </a:extLst>
            </p:cNvPr>
            <p:cNvSpPr/>
            <p:nvPr/>
          </p:nvSpPr>
          <p:spPr>
            <a:xfrm>
              <a:off x="3464874" y="4911803"/>
              <a:ext cx="4119299" cy="36933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5C3BC22-12AE-5548-87EA-9CE0BA94584F}"/>
                </a:ext>
              </a:extLst>
            </p:cNvPr>
            <p:cNvSpPr txBox="1"/>
            <p:nvPr/>
          </p:nvSpPr>
          <p:spPr>
            <a:xfrm>
              <a:off x="3627321" y="4838601"/>
              <a:ext cx="44372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Wash in Restriction Endonuclease Buffer</a:t>
              </a:r>
            </a:p>
          </p:txBody>
        </p:sp>
      </p:grpSp>
      <p:sp>
        <p:nvSpPr>
          <p:cNvPr id="65" name="Bent Arrow 64">
            <a:extLst>
              <a:ext uri="{FF2B5EF4-FFF2-40B4-BE49-F238E27FC236}">
                <a16:creationId xmlns:a16="http://schemas.microsoft.com/office/drawing/2014/main" id="{AA841947-0223-4C48-B0FC-C5E98BC301D7}"/>
              </a:ext>
            </a:extLst>
          </p:cNvPr>
          <p:cNvSpPr/>
          <p:nvPr/>
        </p:nvSpPr>
        <p:spPr>
          <a:xfrm rot="5400000">
            <a:off x="4265148" y="4730410"/>
            <a:ext cx="262372" cy="726807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6" name="Bent Arrow 65">
            <a:extLst>
              <a:ext uri="{FF2B5EF4-FFF2-40B4-BE49-F238E27FC236}">
                <a16:creationId xmlns:a16="http://schemas.microsoft.com/office/drawing/2014/main" id="{CA9AEB97-4AA2-0945-A2D4-B71BA4C84EE7}"/>
              </a:ext>
            </a:extLst>
          </p:cNvPr>
          <p:cNvSpPr/>
          <p:nvPr/>
        </p:nvSpPr>
        <p:spPr>
          <a:xfrm rot="10800000">
            <a:off x="4198299" y="6337025"/>
            <a:ext cx="256639" cy="406266"/>
          </a:xfrm>
          <a:prstGeom prst="ben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90251FF-3525-3840-A36B-5CB950375A50}"/>
              </a:ext>
            </a:extLst>
          </p:cNvPr>
          <p:cNvSpPr txBox="1"/>
          <p:nvPr/>
        </p:nvSpPr>
        <p:spPr>
          <a:xfrm>
            <a:off x="374070" y="8521479"/>
            <a:ext cx="4822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1: </a:t>
            </a:r>
            <a:r>
              <a:rPr lang="en-US" dirty="0"/>
              <a:t>Schema for the DNA Isolation Protocol.</a:t>
            </a:r>
          </a:p>
        </p:txBody>
      </p:sp>
    </p:spTree>
    <p:extLst>
      <p:ext uri="{BB962C8B-B14F-4D97-AF65-F5344CB8AC3E}">
        <p14:creationId xmlns:p14="http://schemas.microsoft.com/office/powerpoint/2010/main" val="13914810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Isosceles Triangle 15">
            <a:extLst>
              <a:ext uri="{FF2B5EF4-FFF2-40B4-BE49-F238E27FC236}">
                <a16:creationId xmlns:a16="http://schemas.microsoft.com/office/drawing/2014/main" id="{DDDD2673-A610-A741-9877-800A0773588B}"/>
              </a:ext>
            </a:extLst>
          </p:cNvPr>
          <p:cNvSpPr/>
          <p:nvPr/>
        </p:nvSpPr>
        <p:spPr>
          <a:xfrm flipV="1">
            <a:off x="2870117" y="5850241"/>
            <a:ext cx="744222" cy="476216"/>
          </a:xfrm>
          <a:prstGeom prst="triangl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10" name="Isosceles Triangle 9"/>
          <p:cNvSpPr/>
          <p:nvPr/>
        </p:nvSpPr>
        <p:spPr>
          <a:xfrm flipV="1">
            <a:off x="2907350" y="2765161"/>
            <a:ext cx="744222" cy="476216"/>
          </a:xfrm>
          <a:prstGeom prst="triangl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13" name="Isosceles Triangle 12"/>
          <p:cNvSpPr/>
          <p:nvPr/>
        </p:nvSpPr>
        <p:spPr>
          <a:xfrm flipV="1">
            <a:off x="2904066" y="3825532"/>
            <a:ext cx="744222" cy="476216"/>
          </a:xfrm>
          <a:prstGeom prst="triangl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16" name="Isosceles Triangle 15"/>
          <p:cNvSpPr/>
          <p:nvPr/>
        </p:nvSpPr>
        <p:spPr>
          <a:xfrm flipV="1">
            <a:off x="2904066" y="4797413"/>
            <a:ext cx="744222" cy="476216"/>
          </a:xfrm>
          <a:prstGeom prst="triangl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sp>
        <p:nvSpPr>
          <p:cNvPr id="7" name="Isosceles Triangle 6"/>
          <p:cNvSpPr/>
          <p:nvPr/>
        </p:nvSpPr>
        <p:spPr>
          <a:xfrm flipV="1">
            <a:off x="2907350" y="1676735"/>
            <a:ext cx="744222" cy="476216"/>
          </a:xfrm>
          <a:prstGeom prst="triangle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chemeClr val="tx1"/>
              </a:solidFill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4C96FF3-F705-6449-98E3-FD344ADAFFC3}"/>
              </a:ext>
            </a:extLst>
          </p:cNvPr>
          <p:cNvGrpSpPr/>
          <p:nvPr/>
        </p:nvGrpSpPr>
        <p:grpSpPr>
          <a:xfrm>
            <a:off x="1670130" y="1194241"/>
            <a:ext cx="3218663" cy="646331"/>
            <a:chOff x="1704045" y="2514295"/>
            <a:chExt cx="3218663" cy="646331"/>
          </a:xfrm>
        </p:grpSpPr>
        <p:sp>
          <p:nvSpPr>
            <p:cNvPr id="6" name="Rectangle 5"/>
            <p:cNvSpPr/>
            <p:nvPr/>
          </p:nvSpPr>
          <p:spPr>
            <a:xfrm>
              <a:off x="1704045" y="2514295"/>
              <a:ext cx="3218663" cy="64633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solidFill>
                  <a:schemeClr val="tx1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49642" y="2547792"/>
              <a:ext cx="2927469" cy="50783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50" b="1" dirty="0"/>
                <a:t>Reference repetitive sequence </a:t>
              </a:r>
            </a:p>
            <a:p>
              <a:pPr algn="ctr"/>
              <a:r>
                <a:rPr lang="en-US" sz="1350" b="1" dirty="0"/>
                <a:t>(include natural variations, if possible)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35B5A763-8DCA-5F4D-A64C-BB49F6251D5E}"/>
              </a:ext>
            </a:extLst>
          </p:cNvPr>
          <p:cNvGrpSpPr/>
          <p:nvPr/>
        </p:nvGrpSpPr>
        <p:grpSpPr>
          <a:xfrm>
            <a:off x="1670130" y="2158630"/>
            <a:ext cx="3218663" cy="758448"/>
            <a:chOff x="1704045" y="3389524"/>
            <a:chExt cx="3218663" cy="758448"/>
          </a:xfrm>
        </p:grpSpPr>
        <p:sp>
          <p:nvSpPr>
            <p:cNvPr id="9" name="Rectangle 8"/>
            <p:cNvSpPr/>
            <p:nvPr/>
          </p:nvSpPr>
          <p:spPr>
            <a:xfrm>
              <a:off x="1704045" y="3389524"/>
              <a:ext cx="3218663" cy="758448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solidFill>
                  <a:schemeClr val="tx1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825372" y="3397012"/>
              <a:ext cx="2976008" cy="71558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50" b="1" i="1" dirty="0"/>
                <a:t>In-silico</a:t>
              </a:r>
              <a:r>
                <a:rPr lang="en-US" sz="1350" b="1" dirty="0"/>
                <a:t> RE digestion </a:t>
              </a:r>
            </a:p>
            <a:p>
              <a:pPr algn="ctr"/>
              <a:r>
                <a:rPr lang="en-US" sz="1350" b="1" dirty="0"/>
                <a:t>(to identify the commercially available </a:t>
              </a:r>
            </a:p>
            <a:p>
              <a:pPr algn="ctr"/>
              <a:r>
                <a:rPr lang="en-US" sz="1350" b="1" dirty="0"/>
                <a:t>non-cutters) 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3E65964D-CE01-CA44-9D9E-EF1BE4DDB970}"/>
              </a:ext>
            </a:extLst>
          </p:cNvPr>
          <p:cNvGrpSpPr/>
          <p:nvPr/>
        </p:nvGrpSpPr>
        <p:grpSpPr>
          <a:xfrm>
            <a:off x="1659273" y="3235136"/>
            <a:ext cx="3233809" cy="733982"/>
            <a:chOff x="1693188" y="4363752"/>
            <a:chExt cx="3233809" cy="733982"/>
          </a:xfrm>
        </p:grpSpPr>
        <p:sp>
          <p:nvSpPr>
            <p:cNvPr id="12" name="Rectangle 11"/>
            <p:cNvSpPr/>
            <p:nvPr/>
          </p:nvSpPr>
          <p:spPr>
            <a:xfrm>
              <a:off x="1700761" y="4363752"/>
              <a:ext cx="3218663" cy="721554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solidFill>
                  <a:schemeClr val="tx1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693188" y="4382153"/>
              <a:ext cx="3233809" cy="71558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50" b="1" dirty="0"/>
                <a:t>Find the distribution and the median restriction fragment length for the genome using target sequence non-cutters 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604A6351-765E-5D47-80E8-C2B575D98B3D}"/>
              </a:ext>
            </a:extLst>
          </p:cNvPr>
          <p:cNvGrpSpPr/>
          <p:nvPr/>
        </p:nvGrpSpPr>
        <p:grpSpPr>
          <a:xfrm>
            <a:off x="1666846" y="4287176"/>
            <a:ext cx="3218663" cy="646331"/>
            <a:chOff x="1700761" y="5339140"/>
            <a:chExt cx="3218663" cy="646331"/>
          </a:xfrm>
        </p:grpSpPr>
        <p:sp>
          <p:nvSpPr>
            <p:cNvPr id="15" name="Rectangle 14"/>
            <p:cNvSpPr/>
            <p:nvPr/>
          </p:nvSpPr>
          <p:spPr>
            <a:xfrm>
              <a:off x="1700761" y="5339140"/>
              <a:ext cx="3218663" cy="64633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solidFill>
                  <a:schemeClr val="tx1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713897" y="5363967"/>
              <a:ext cx="3192390" cy="50783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50" b="1" dirty="0"/>
                <a:t>Select frequent genomic cutters (based on the median fragment length)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428F9AFE-6696-AC49-941D-3B745C9D9D51}"/>
              </a:ext>
            </a:extLst>
          </p:cNvPr>
          <p:cNvGrpSpPr/>
          <p:nvPr/>
        </p:nvGrpSpPr>
        <p:grpSpPr>
          <a:xfrm>
            <a:off x="1653709" y="5251565"/>
            <a:ext cx="3218663" cy="748570"/>
            <a:chOff x="1700761" y="6177598"/>
            <a:chExt cx="3218663" cy="748570"/>
          </a:xfrm>
        </p:grpSpPr>
        <p:sp>
          <p:nvSpPr>
            <p:cNvPr id="19" name="Rectangle 18"/>
            <p:cNvSpPr/>
            <p:nvPr/>
          </p:nvSpPr>
          <p:spPr>
            <a:xfrm>
              <a:off x="1700761" y="6177598"/>
              <a:ext cx="3218663" cy="748115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solidFill>
                  <a:schemeClr val="tx1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734709" y="6210587"/>
              <a:ext cx="3150766" cy="71558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50" b="1" dirty="0"/>
                <a:t>Group frequent genomic cutters based on their performance in the common buffers</a:t>
              </a:r>
            </a:p>
            <a:p>
              <a:pPr algn="ctr"/>
              <a:r>
                <a:rPr lang="en-US" sz="1350" b="1" dirty="0"/>
                <a:t>(e.g., CutSmart buffer) 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205F2158-8DBE-794D-9AF9-3809A3B31E28}"/>
              </a:ext>
            </a:extLst>
          </p:cNvPr>
          <p:cNvSpPr txBox="1"/>
          <p:nvPr/>
        </p:nvSpPr>
        <p:spPr>
          <a:xfrm>
            <a:off x="397432" y="7626593"/>
            <a:ext cx="643381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2: </a:t>
            </a:r>
            <a:r>
              <a:rPr lang="en-US" dirty="0"/>
              <a:t>Strategy for selecting optimal restriction endonucleases </a:t>
            </a:r>
          </a:p>
          <a:p>
            <a:r>
              <a:rPr lang="en-US" dirty="0"/>
              <a:t>(REs) to enrich for repetitive genomic regions of interest.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41CC2619-193E-F442-B276-3FBE97F303A6}"/>
              </a:ext>
            </a:extLst>
          </p:cNvPr>
          <p:cNvGrpSpPr/>
          <p:nvPr/>
        </p:nvGrpSpPr>
        <p:grpSpPr>
          <a:xfrm>
            <a:off x="1666846" y="6318195"/>
            <a:ext cx="3218663" cy="745419"/>
            <a:chOff x="1700761" y="7118295"/>
            <a:chExt cx="3218663" cy="745419"/>
          </a:xfrm>
        </p:grpSpPr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AA322AD4-BE0F-F742-8D0A-02FA3CE6622D}"/>
                </a:ext>
              </a:extLst>
            </p:cNvPr>
            <p:cNvSpPr/>
            <p:nvPr/>
          </p:nvSpPr>
          <p:spPr>
            <a:xfrm>
              <a:off x="1700761" y="7118295"/>
              <a:ext cx="3218663" cy="74541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solidFill>
                  <a:schemeClr val="tx1"/>
                </a:solidFill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3CE80FD-74EF-B24E-88E1-C925C3AFA5F3}"/>
                </a:ext>
              </a:extLst>
            </p:cNvPr>
            <p:cNvSpPr txBox="1"/>
            <p:nvPr/>
          </p:nvSpPr>
          <p:spPr>
            <a:xfrm>
              <a:off x="1734709" y="7136680"/>
              <a:ext cx="3150766" cy="71558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50" b="1" dirty="0"/>
                <a:t>Identify a minimal set of REs by assessing </a:t>
              </a:r>
            </a:p>
            <a:p>
              <a:pPr algn="ctr"/>
              <a:r>
                <a:rPr lang="en-US" sz="1350" b="1" dirty="0"/>
                <a:t>the distribution and the median restriction fragment length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41099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A25E49-FDE3-F04B-862D-9F9F611911A0}"/>
              </a:ext>
            </a:extLst>
          </p:cNvPr>
          <p:cNvSpPr txBox="1"/>
          <p:nvPr/>
        </p:nvSpPr>
        <p:spPr>
          <a:xfrm>
            <a:off x="274320" y="6270228"/>
            <a:ext cx="67360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3: </a:t>
            </a:r>
            <a:r>
              <a:rPr lang="en-US" i="1" dirty="0"/>
              <a:t>In-silico</a:t>
            </a:r>
            <a:r>
              <a:rPr lang="en-US" dirty="0"/>
              <a:t> digestion of an </a:t>
            </a:r>
            <a:r>
              <a:rPr lang="en-US" i="1" dirty="0"/>
              <a:t>A. thaliana </a:t>
            </a:r>
            <a:r>
              <a:rPr lang="en-US" dirty="0"/>
              <a:t>rRNA gene reference sequence with restriction endonucleases that exhibit 100% activity in CutSmart Buffer. Combo1 – all 15 REs; Combo2 – 11 REs (excludes Acc65I, </a:t>
            </a:r>
            <a:r>
              <a:rPr lang="en-US" dirty="0" err="1"/>
              <a:t>BstXI</a:t>
            </a:r>
            <a:r>
              <a:rPr lang="en-US" dirty="0"/>
              <a:t>, </a:t>
            </a:r>
            <a:r>
              <a:rPr lang="en-US" dirty="0" err="1"/>
              <a:t>BstEII</a:t>
            </a:r>
            <a:r>
              <a:rPr lang="en-US" dirty="0"/>
              <a:t>, and </a:t>
            </a:r>
            <a:r>
              <a:rPr lang="en-US" dirty="0" err="1"/>
              <a:t>BstI</a:t>
            </a:r>
            <a:r>
              <a:rPr lang="en-US" dirty="0"/>
              <a:t>); Combo3 – 6 REs (See Figure 1A)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21F4645-F3F4-D74B-8A22-09ADD3EBE7E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r="427" b="3537"/>
          <a:stretch/>
        </p:blipFill>
        <p:spPr>
          <a:xfrm>
            <a:off x="0" y="1901371"/>
            <a:ext cx="6719954" cy="397128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0E2C1FB-179A-8A45-9B61-F5D4581DF1F7}"/>
              </a:ext>
            </a:extLst>
          </p:cNvPr>
          <p:cNvSpPr txBox="1"/>
          <p:nvPr/>
        </p:nvSpPr>
        <p:spPr>
          <a:xfrm>
            <a:off x="2520452" y="5932941"/>
            <a:ext cx="16790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estriction </a:t>
            </a:r>
            <a:r>
              <a:rPr lang="en-US" sz="1200" dirty="0" err="1"/>
              <a:t>endouclease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304868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26</TotalTime>
  <Words>230</Words>
  <Application>Microsoft Macintosh PowerPoint</Application>
  <PresentationFormat>Letter Paper (8.5x11 in)</PresentationFormat>
  <Paragraphs>3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Kinlay, Anastasia</dc:creator>
  <cp:lastModifiedBy>Pikaard, Craig</cp:lastModifiedBy>
  <cp:revision>16</cp:revision>
  <dcterms:created xsi:type="dcterms:W3CDTF">2021-02-22T20:08:23Z</dcterms:created>
  <dcterms:modified xsi:type="dcterms:W3CDTF">2021-03-25T20:29:21Z</dcterms:modified>
</cp:coreProperties>
</file>